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45" d="100"/>
          <a:sy n="45" d="100"/>
        </p:scale>
        <p:origin x="24" y="9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5611-4FC3-4EA8-A5FC-5650CE91A4C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35F78-1FCC-46D1-A949-C7D0EA90AB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5218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5611-4FC3-4EA8-A5FC-5650CE91A4C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35F78-1FCC-46D1-A949-C7D0EA90AB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6088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5611-4FC3-4EA8-A5FC-5650CE91A4C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35F78-1FCC-46D1-A949-C7D0EA90AB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3434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5611-4FC3-4EA8-A5FC-5650CE91A4C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35F78-1FCC-46D1-A949-C7D0EA90AB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25302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5611-4FC3-4EA8-A5FC-5650CE91A4C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35F78-1FCC-46D1-A949-C7D0EA90AB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46370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5611-4FC3-4EA8-A5FC-5650CE91A4C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35F78-1FCC-46D1-A949-C7D0EA90AB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9930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5611-4FC3-4EA8-A5FC-5650CE91A4C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35F78-1FCC-46D1-A949-C7D0EA90AB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9190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5611-4FC3-4EA8-A5FC-5650CE91A4C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35F78-1FCC-46D1-A949-C7D0EA90AB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6934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5611-4FC3-4EA8-A5FC-5650CE91A4C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35F78-1FCC-46D1-A949-C7D0EA90AB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309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5611-4FC3-4EA8-A5FC-5650CE91A4C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35F78-1FCC-46D1-A949-C7D0EA90AB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2030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5611-4FC3-4EA8-A5FC-5650CE91A4C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35F78-1FCC-46D1-A949-C7D0EA90AB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6072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005611-4FC3-4EA8-A5FC-5650CE91A4C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E35F78-1FCC-46D1-A949-C7D0EA90AB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9669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04503" y="935723"/>
            <a:ext cx="8318066" cy="4711098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965200" y="5774267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S23.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Correlation between β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log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)) an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log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)) for biquinolines against sensitive strain W2 and D6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28644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17:04Z</dcterms:created>
  <dcterms:modified xsi:type="dcterms:W3CDTF">2020-08-04T16:36:01Z</dcterms:modified>
</cp:coreProperties>
</file>